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4" userDrawn="1">
          <p15:clr>
            <a:srgbClr val="A4A3A4"/>
          </p15:clr>
        </p15:guide>
        <p15:guide id="2" pos="1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8986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59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330" y="102"/>
      </p:cViewPr>
      <p:guideLst>
        <p:guide orient="horz" pos="164"/>
        <p:guide pos="1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159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5228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1663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2498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185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2289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23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251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725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7967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4275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3D1EC0-22D7-467F-91F9-A737283A2C9B}" type="datetimeFigureOut">
              <a:rPr lang="en-GB" smtClean="0"/>
              <a:t>22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E361A-3278-4C1F-9AFB-35043C08A2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680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273155" y="635242"/>
            <a:ext cx="7067236" cy="5046158"/>
            <a:chOff x="1273155" y="635242"/>
            <a:chExt cx="7067236" cy="5046158"/>
          </a:xfrm>
        </p:grpSpPr>
        <p:grpSp>
          <p:nvGrpSpPr>
            <p:cNvPr id="47" name="Group 46"/>
            <p:cNvGrpSpPr/>
            <p:nvPr/>
          </p:nvGrpSpPr>
          <p:grpSpPr>
            <a:xfrm>
              <a:off x="1357353" y="635242"/>
              <a:ext cx="6770647" cy="3926171"/>
              <a:chOff x="1357353" y="842295"/>
              <a:chExt cx="6770647" cy="3926171"/>
            </a:xfrm>
          </p:grpSpPr>
          <p:grpSp>
            <p:nvGrpSpPr>
              <p:cNvPr id="44" name="Group 43"/>
              <p:cNvGrpSpPr/>
              <p:nvPr/>
            </p:nvGrpSpPr>
            <p:grpSpPr>
              <a:xfrm>
                <a:off x="1405201" y="2794391"/>
                <a:ext cx="6473979" cy="1916144"/>
                <a:chOff x="1405201" y="3123089"/>
                <a:chExt cx="6473979" cy="1916144"/>
              </a:xfrm>
            </p:grpSpPr>
            <p:grpSp>
              <p:nvGrpSpPr>
                <p:cNvPr id="27" name="Group 26"/>
                <p:cNvGrpSpPr/>
                <p:nvPr/>
              </p:nvGrpSpPr>
              <p:grpSpPr>
                <a:xfrm>
                  <a:off x="1405201" y="3280968"/>
                  <a:ext cx="6459834" cy="1670650"/>
                  <a:chOff x="1405201" y="3280968"/>
                  <a:chExt cx="6459834" cy="1670650"/>
                </a:xfrm>
              </p:grpSpPr>
              <p:pic>
                <p:nvPicPr>
                  <p:cNvPr id="8" name="Picture 7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817" t="13130" r="864" b="4281"/>
                  <a:stretch/>
                </p:blipFill>
                <p:spPr>
                  <a:xfrm>
                    <a:off x="1607670" y="3451411"/>
                    <a:ext cx="6257365" cy="1329765"/>
                  </a:xfrm>
                  <a:prstGeom prst="rect">
                    <a:avLst/>
                  </a:prstGeom>
                </p:spPr>
              </p:pic>
              <p:sp>
                <p:nvSpPr>
                  <p:cNvPr id="10" name="TextBox 9"/>
                  <p:cNvSpPr txBox="1"/>
                  <p:nvPr/>
                </p:nvSpPr>
                <p:spPr>
                  <a:xfrm rot="16200000">
                    <a:off x="677598" y="4008571"/>
                    <a:ext cx="16706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/>
                      <a:t>Average rank order across 11 traits</a:t>
                    </a:r>
                    <a:endParaRPr lang="en-GB" sz="800" b="1" dirty="0"/>
                  </a:p>
                </p:txBody>
              </p:sp>
            </p:grpSp>
            <p:sp>
              <p:nvSpPr>
                <p:cNvPr id="32" name="TextBox 31"/>
                <p:cNvSpPr txBox="1"/>
                <p:nvPr/>
              </p:nvSpPr>
              <p:spPr>
                <a:xfrm>
                  <a:off x="1748118" y="3123089"/>
                  <a:ext cx="2988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/>
                    <a:t>B</a:t>
                  </a:r>
                </a:p>
              </p:txBody>
            </p:sp>
            <p:grpSp>
              <p:nvGrpSpPr>
                <p:cNvPr id="39" name="Group 38"/>
                <p:cNvGrpSpPr/>
                <p:nvPr/>
              </p:nvGrpSpPr>
              <p:grpSpPr>
                <a:xfrm>
                  <a:off x="1639371" y="4823789"/>
                  <a:ext cx="6239809" cy="215444"/>
                  <a:chOff x="1619250" y="2552116"/>
                  <a:chExt cx="6239809" cy="215444"/>
                </a:xfrm>
              </p:grpSpPr>
              <p:cxnSp>
                <p:nvCxnSpPr>
                  <p:cNvPr id="34" name="Straight Arrow Connector 33"/>
                  <p:cNvCxnSpPr/>
                  <p:nvPr/>
                </p:nvCxnSpPr>
                <p:spPr>
                  <a:xfrm>
                    <a:off x="1619250" y="2659838"/>
                    <a:ext cx="6239809" cy="0"/>
                  </a:xfrm>
                  <a:prstGeom prst="straightConnector1">
                    <a:avLst/>
                  </a:prstGeom>
                  <a:ln w="19050">
                    <a:solidFill>
                      <a:schemeClr val="accent1">
                        <a:lumMod val="50000"/>
                      </a:schemeClr>
                    </a:solidFill>
                    <a:headEnd type="arrow" w="med" len="med"/>
                    <a:tailEnd type="arrow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4057717" y="2552116"/>
                    <a:ext cx="1362874" cy="215444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err="1" smtClean="0"/>
                      <a:t>Fp</a:t>
                    </a:r>
                    <a:r>
                      <a:rPr lang="en-GB" sz="800" b="1" dirty="0" smtClean="0"/>
                      <a:t>, </a:t>
                    </a:r>
                    <a:r>
                      <a:rPr lang="en-GB" sz="800" b="1" dirty="0" err="1" smtClean="0"/>
                      <a:t>LpM</a:t>
                    </a:r>
                    <a:r>
                      <a:rPr lang="en-GB" sz="800" b="1" dirty="0" smtClean="0"/>
                      <a:t>, </a:t>
                    </a:r>
                    <a:r>
                      <a:rPr lang="en-GB" sz="800" b="1" dirty="0" err="1" smtClean="0"/>
                      <a:t>LpL</a:t>
                    </a:r>
                    <a:r>
                      <a:rPr lang="en-GB" sz="800" b="1" dirty="0" smtClean="0"/>
                      <a:t>, S1-7, </a:t>
                    </a:r>
                    <a:r>
                      <a:rPr lang="en-GB" sz="800" b="1" dirty="0" err="1" smtClean="0"/>
                      <a:t>LpFpFam</a:t>
                    </a:r>
                    <a:endParaRPr lang="en-GB" sz="800" b="1" dirty="0"/>
                  </a:p>
                </p:txBody>
              </p:sp>
            </p:grpSp>
          </p:grpSp>
          <p:grpSp>
            <p:nvGrpSpPr>
              <p:cNvPr id="43" name="Group 42"/>
              <p:cNvGrpSpPr/>
              <p:nvPr/>
            </p:nvGrpSpPr>
            <p:grpSpPr>
              <a:xfrm>
                <a:off x="1398860" y="842295"/>
                <a:ext cx="6525563" cy="1958599"/>
                <a:chOff x="1398860" y="776559"/>
                <a:chExt cx="6525563" cy="1958599"/>
              </a:xfrm>
            </p:grpSpPr>
            <p:grpSp>
              <p:nvGrpSpPr>
                <p:cNvPr id="26" name="Group 25"/>
                <p:cNvGrpSpPr/>
                <p:nvPr/>
              </p:nvGrpSpPr>
              <p:grpSpPr>
                <a:xfrm>
                  <a:off x="1398860" y="882910"/>
                  <a:ext cx="6466176" cy="1670650"/>
                  <a:chOff x="1398860" y="882910"/>
                  <a:chExt cx="6466176" cy="1670650"/>
                </a:xfrm>
              </p:grpSpPr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532" t="12680" r="863" b="4930"/>
                  <a:stretch/>
                </p:blipFill>
                <p:spPr>
                  <a:xfrm>
                    <a:off x="1589742" y="1051859"/>
                    <a:ext cx="6275294" cy="1332753"/>
                  </a:xfrm>
                  <a:prstGeom prst="rect">
                    <a:avLst/>
                  </a:prstGeom>
                </p:spPr>
              </p:pic>
              <p:sp>
                <p:nvSpPr>
                  <p:cNvPr id="9" name="TextBox 8"/>
                  <p:cNvSpPr txBox="1"/>
                  <p:nvPr/>
                </p:nvSpPr>
                <p:spPr>
                  <a:xfrm rot="16200000">
                    <a:off x="671257" y="1610513"/>
                    <a:ext cx="16706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/>
                      <a:t>Average rank order across 11 traits</a:t>
                    </a:r>
                    <a:endParaRPr lang="en-GB" sz="800" b="1" dirty="0"/>
                  </a:p>
                </p:txBody>
              </p:sp>
            </p:grpSp>
            <p:sp>
              <p:nvSpPr>
                <p:cNvPr id="28" name="TextBox 27"/>
                <p:cNvSpPr txBox="1"/>
                <p:nvPr/>
              </p:nvSpPr>
              <p:spPr>
                <a:xfrm>
                  <a:off x="1680406" y="2342783"/>
                  <a:ext cx="624401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/>
                    <a:t>4    F    L                    3                                                                    5                                                                                 1                2                      7        6                     M</a:t>
                  </a:r>
                  <a:endParaRPr lang="en-GB" sz="800" b="1" dirty="0"/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1801401" y="776559"/>
                  <a:ext cx="2988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b="1" dirty="0" smtClean="0"/>
                    <a:t>A</a:t>
                  </a:r>
                  <a:endParaRPr lang="en-GB" sz="1400" b="1" dirty="0"/>
                </a:p>
              </p:txBody>
            </p:sp>
            <p:grpSp>
              <p:nvGrpSpPr>
                <p:cNvPr id="40" name="Group 39"/>
                <p:cNvGrpSpPr/>
                <p:nvPr/>
              </p:nvGrpSpPr>
              <p:grpSpPr>
                <a:xfrm>
                  <a:off x="1639370" y="2519714"/>
                  <a:ext cx="6239809" cy="215444"/>
                  <a:chOff x="1619250" y="2552116"/>
                  <a:chExt cx="6239809" cy="215444"/>
                </a:xfrm>
              </p:grpSpPr>
              <p:cxnSp>
                <p:nvCxnSpPr>
                  <p:cNvPr id="41" name="Straight Arrow Connector 40"/>
                  <p:cNvCxnSpPr/>
                  <p:nvPr/>
                </p:nvCxnSpPr>
                <p:spPr>
                  <a:xfrm>
                    <a:off x="1619250" y="2659838"/>
                    <a:ext cx="6239809" cy="0"/>
                  </a:xfrm>
                  <a:prstGeom prst="straightConnector1">
                    <a:avLst/>
                  </a:prstGeom>
                  <a:ln w="19050">
                    <a:solidFill>
                      <a:schemeClr val="accent1">
                        <a:lumMod val="50000"/>
                      </a:schemeClr>
                    </a:solidFill>
                    <a:headEnd type="arrow" w="med" len="med"/>
                    <a:tailEnd type="arrow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4057717" y="2552116"/>
                    <a:ext cx="1362874" cy="215444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err="1" smtClean="0"/>
                      <a:t>Fp</a:t>
                    </a:r>
                    <a:r>
                      <a:rPr lang="en-GB" sz="800" b="1" dirty="0" smtClean="0"/>
                      <a:t>, </a:t>
                    </a:r>
                    <a:r>
                      <a:rPr lang="en-GB" sz="800" b="1" dirty="0" err="1" smtClean="0"/>
                      <a:t>LpM</a:t>
                    </a:r>
                    <a:r>
                      <a:rPr lang="en-GB" sz="800" b="1" dirty="0" smtClean="0"/>
                      <a:t>, </a:t>
                    </a:r>
                    <a:r>
                      <a:rPr lang="en-GB" sz="800" b="1" dirty="0" err="1" smtClean="0"/>
                      <a:t>LpL</a:t>
                    </a:r>
                    <a:r>
                      <a:rPr lang="en-GB" sz="800" b="1" dirty="0" smtClean="0"/>
                      <a:t>, S1-7, </a:t>
                    </a:r>
                    <a:r>
                      <a:rPr lang="en-GB" sz="800" b="1" dirty="0" err="1" smtClean="0"/>
                      <a:t>LpFpFam</a:t>
                    </a:r>
                    <a:endParaRPr lang="en-GB" sz="800" b="1" dirty="0"/>
                  </a:p>
                </p:txBody>
              </p:sp>
            </p:grpSp>
          </p:grpSp>
          <p:sp>
            <p:nvSpPr>
              <p:cNvPr id="45" name="Rectangle 44"/>
              <p:cNvSpPr/>
              <p:nvPr/>
            </p:nvSpPr>
            <p:spPr>
              <a:xfrm>
                <a:off x="1357353" y="885962"/>
                <a:ext cx="6770647" cy="194359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1357353" y="2824875"/>
                <a:ext cx="6770647" cy="194359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1273155" y="4911959"/>
              <a:ext cx="7067236" cy="769441"/>
              <a:chOff x="1273155" y="4911959"/>
              <a:chExt cx="7067236" cy="769441"/>
            </a:xfrm>
          </p:grpSpPr>
          <p:sp>
            <p:nvSpPr>
              <p:cNvPr id="35" name="TextBox 34"/>
              <p:cNvSpPr txBox="1"/>
              <p:nvPr/>
            </p:nvSpPr>
            <p:spPr>
              <a:xfrm>
                <a:off x="1273155" y="4911959"/>
                <a:ext cx="7067236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/>
                  <a:t>S3 Fig. </a:t>
                </a:r>
                <a:r>
                  <a:rPr lang="en-GB" sz="1100" dirty="0" smtClean="0"/>
                  <a:t>Average</a:t>
                </a:r>
                <a:r>
                  <a:rPr lang="en-GB" sz="1100" b="1" dirty="0" smtClean="0"/>
                  <a:t> </a:t>
                </a:r>
                <a:r>
                  <a:rPr lang="en-GB" sz="1100" dirty="0"/>
                  <a:t>r</a:t>
                </a:r>
                <a:r>
                  <a:rPr lang="en-GB" sz="1100" dirty="0" smtClean="0"/>
                  <a:t>ank order across 11 independently measured traits. </a:t>
                </a:r>
                <a:r>
                  <a:rPr lang="en-GB" sz="1100" b="1" dirty="0" smtClean="0"/>
                  <a:t>S3A</a:t>
                </a:r>
                <a:r>
                  <a:rPr lang="en-GB" sz="1100" dirty="0" smtClean="0"/>
                  <a:t>. F    = </a:t>
                </a:r>
                <a:r>
                  <a:rPr lang="en-GB" sz="1100" dirty="0" err="1" smtClean="0"/>
                  <a:t>Fp</a:t>
                </a:r>
                <a:r>
                  <a:rPr lang="en-GB" sz="1100" dirty="0" smtClean="0"/>
                  <a:t>, L    = </a:t>
                </a:r>
                <a:r>
                  <a:rPr lang="en-GB" sz="1100" dirty="0" err="1" smtClean="0"/>
                  <a:t>LpL</a:t>
                </a:r>
                <a:r>
                  <a:rPr lang="en-GB" sz="1100" dirty="0" smtClean="0"/>
                  <a:t>, M    =</a:t>
                </a:r>
                <a:r>
                  <a:rPr lang="en-GB" sz="1100" dirty="0" err="1" smtClean="0"/>
                  <a:t>LpM</a:t>
                </a:r>
                <a:r>
                  <a:rPr lang="en-GB" sz="1100" dirty="0" smtClean="0"/>
                  <a:t>, 1    = S1, 2    = S2, 3    = S3, 4    =S4,  5    = S5, 6    = S6, 7    = S7, no label    = </a:t>
                </a:r>
                <a:r>
                  <a:rPr lang="en-GB" sz="1100" dirty="0" err="1" smtClean="0"/>
                  <a:t>LpFpfam</a:t>
                </a:r>
                <a:r>
                  <a:rPr lang="en-GB" sz="1100" dirty="0" smtClean="0"/>
                  <a:t> genotypes.</a:t>
                </a:r>
                <a:r>
                  <a:rPr lang="en-GB" sz="1100" b="1" dirty="0" smtClean="0"/>
                  <a:t> S3B</a:t>
                </a:r>
                <a:r>
                  <a:rPr lang="en-GB" sz="1100" dirty="0" smtClean="0"/>
                  <a:t>.    = S4,    = S4fam Group 1 genotypes,                      </a:t>
                </a:r>
                <a:r>
                  <a:rPr lang="en-GB" sz="1100" dirty="0" smtClean="0">
                    <a:solidFill>
                      <a:schemeClr val="bg1"/>
                    </a:solidFill>
                  </a:rPr>
                  <a:t>…</a:t>
                </a:r>
                <a:r>
                  <a:rPr lang="en-GB" sz="1100" dirty="0" smtClean="0"/>
                  <a:t>=S4fam </a:t>
                </a:r>
                <a:r>
                  <a:rPr lang="en-GB" sz="1100" dirty="0" smtClean="0"/>
                  <a:t>Group2 </a:t>
                </a:r>
                <a:r>
                  <a:rPr lang="en-GB" sz="1100" dirty="0" smtClean="0"/>
                  <a:t>genotypes,    = remainder of parental and </a:t>
                </a:r>
                <a:r>
                  <a:rPr lang="en-GB" sz="1100" dirty="0" err="1" smtClean="0"/>
                  <a:t>LpFpFam</a:t>
                </a:r>
                <a:r>
                  <a:rPr lang="en-GB" sz="1100" dirty="0" smtClean="0"/>
                  <a:t> genotypes. Group 1 and Group 2 genotypes contain </a:t>
                </a:r>
                <a:r>
                  <a:rPr lang="en-GB" sz="1100" i="1" dirty="0" smtClean="0"/>
                  <a:t>F. pratensis </a:t>
                </a:r>
                <a:r>
                  <a:rPr lang="en-GB" sz="1100" dirty="0" err="1" smtClean="0"/>
                  <a:t>introgressions</a:t>
                </a:r>
                <a:r>
                  <a:rPr lang="en-GB" sz="1100" dirty="0" smtClean="0"/>
                  <a:t> with different ends of </a:t>
                </a:r>
                <a:r>
                  <a:rPr lang="en-GB" sz="1100" dirty="0" err="1" smtClean="0"/>
                  <a:t>Fp</a:t>
                </a:r>
                <a:r>
                  <a:rPr lang="en-GB" sz="1100" dirty="0" smtClean="0"/>
                  <a:t> C4 (see Figs 3 and 4).</a:t>
                </a:r>
                <a:endParaRPr lang="en-GB" sz="1100" dirty="0"/>
              </a:p>
            </p:txBody>
          </p:sp>
          <p:grpSp>
            <p:nvGrpSpPr>
              <p:cNvPr id="36" name="Group 35"/>
              <p:cNvGrpSpPr/>
              <p:nvPr/>
            </p:nvGrpSpPr>
            <p:grpSpPr>
              <a:xfrm>
                <a:off x="5659413" y="4988726"/>
                <a:ext cx="2231986" cy="125179"/>
                <a:chOff x="5265466" y="4689031"/>
                <a:chExt cx="2231986" cy="125179"/>
              </a:xfrm>
            </p:grpSpPr>
            <p:sp>
              <p:nvSpPr>
                <p:cNvPr id="59" name="Rectangle 58"/>
                <p:cNvSpPr/>
                <p:nvPr/>
              </p:nvSpPr>
              <p:spPr>
                <a:xfrm>
                  <a:off x="5265466" y="4689031"/>
                  <a:ext cx="58389" cy="125179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0" name="Rectangle 59"/>
                <p:cNvSpPr/>
                <p:nvPr/>
              </p:nvSpPr>
              <p:spPr>
                <a:xfrm>
                  <a:off x="7439063" y="4689031"/>
                  <a:ext cx="58389" cy="125179"/>
                </a:xfrm>
                <a:prstGeom prst="rect">
                  <a:avLst/>
                </a:prstGeom>
                <a:solidFill>
                  <a:srgbClr val="989862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1" name="Rectangle 60"/>
                <p:cNvSpPr/>
                <p:nvPr/>
              </p:nvSpPr>
              <p:spPr>
                <a:xfrm>
                  <a:off x="6931683" y="4689031"/>
                  <a:ext cx="58389" cy="125179"/>
                </a:xfrm>
                <a:prstGeom prst="rect">
                  <a:avLst/>
                </a:prstGeom>
                <a:solidFill>
                  <a:srgbClr val="7030A0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2" name="Rectangle 61"/>
                <p:cNvSpPr/>
                <p:nvPr/>
              </p:nvSpPr>
              <p:spPr>
                <a:xfrm>
                  <a:off x="6353246" y="4689031"/>
                  <a:ext cx="58389" cy="125179"/>
                </a:xfrm>
                <a:prstGeom prst="rect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3" name="Rectangle 62"/>
                <p:cNvSpPr/>
                <p:nvPr/>
              </p:nvSpPr>
              <p:spPr>
                <a:xfrm>
                  <a:off x="5754416" y="4689031"/>
                  <a:ext cx="58389" cy="125179"/>
                </a:xfrm>
                <a:prstGeom prst="rect">
                  <a:avLst/>
                </a:prstGeom>
                <a:solidFill>
                  <a:schemeClr val="accent6">
                    <a:lumMod val="7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37" name="Group 36"/>
              <p:cNvGrpSpPr/>
              <p:nvPr/>
            </p:nvGrpSpPr>
            <p:grpSpPr>
              <a:xfrm>
                <a:off x="1464026" y="5149450"/>
                <a:ext cx="4994230" cy="125179"/>
                <a:chOff x="1464026" y="5149450"/>
                <a:chExt cx="4994230" cy="125179"/>
              </a:xfrm>
            </p:grpSpPr>
            <p:sp>
              <p:nvSpPr>
                <p:cNvPr id="51" name="Rectangle 50"/>
                <p:cNvSpPr/>
                <p:nvPr/>
              </p:nvSpPr>
              <p:spPr>
                <a:xfrm>
                  <a:off x="6399867" y="5149450"/>
                  <a:ext cx="58389" cy="125179"/>
                </a:xfrm>
                <a:prstGeom prst="rect">
                  <a:avLst/>
                </a:prstGeom>
                <a:solidFill>
                  <a:schemeClr val="accent4">
                    <a:lumMod val="7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2" name="Rectangle 51"/>
                <p:cNvSpPr/>
                <p:nvPr/>
              </p:nvSpPr>
              <p:spPr>
                <a:xfrm>
                  <a:off x="5999817" y="5149450"/>
                  <a:ext cx="58389" cy="125179"/>
                </a:xfrm>
                <a:prstGeom prst="rect">
                  <a:avLst/>
                </a:prstGeom>
                <a:solidFill>
                  <a:schemeClr val="accent2">
                    <a:lumMod val="50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3" name="Rectangle 52"/>
                <p:cNvSpPr/>
                <p:nvPr/>
              </p:nvSpPr>
              <p:spPr>
                <a:xfrm>
                  <a:off x="4348817" y="5149450"/>
                  <a:ext cx="58389" cy="125179"/>
                </a:xfrm>
                <a:prstGeom prst="rect">
                  <a:avLst/>
                </a:prstGeom>
                <a:noFill/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4" name="Rectangle 53"/>
                <p:cNvSpPr/>
                <p:nvPr/>
              </p:nvSpPr>
              <p:spPr>
                <a:xfrm>
                  <a:off x="2465037" y="5149450"/>
                  <a:ext cx="58389" cy="12517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5" name="Rectangle 54"/>
                <p:cNvSpPr/>
                <p:nvPr/>
              </p:nvSpPr>
              <p:spPr>
                <a:xfrm>
                  <a:off x="3482661" y="5149450"/>
                  <a:ext cx="58389" cy="125179"/>
                </a:xfrm>
                <a:prstGeom prst="rect">
                  <a:avLst/>
                </a:prstGeom>
                <a:solidFill>
                  <a:srgbClr val="00B0F0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6" name="Rectangle 55"/>
                <p:cNvSpPr/>
                <p:nvPr/>
              </p:nvSpPr>
              <p:spPr>
                <a:xfrm>
                  <a:off x="2975520" y="5149450"/>
                  <a:ext cx="58389" cy="125179"/>
                </a:xfrm>
                <a:prstGeom prst="rect">
                  <a:avLst/>
                </a:prstGeom>
                <a:solidFill>
                  <a:srgbClr val="860000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7" name="Rectangle 56"/>
                <p:cNvSpPr/>
                <p:nvPr/>
              </p:nvSpPr>
              <p:spPr>
                <a:xfrm>
                  <a:off x="1954554" y="5149450"/>
                  <a:ext cx="58389" cy="125179"/>
                </a:xfrm>
                <a:prstGeom prst="rect">
                  <a:avLst/>
                </a:prstGeom>
                <a:solidFill>
                  <a:schemeClr val="accent2">
                    <a:lumMod val="50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8" name="Rectangle 57"/>
                <p:cNvSpPr/>
                <p:nvPr/>
              </p:nvSpPr>
              <p:spPr>
                <a:xfrm>
                  <a:off x="1464026" y="5149450"/>
                  <a:ext cx="58389" cy="125179"/>
                </a:xfrm>
                <a:prstGeom prst="rect">
                  <a:avLst/>
                </a:prstGeom>
                <a:solidFill>
                  <a:schemeClr val="accent1">
                    <a:lumMod val="50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48" name="Group 47"/>
              <p:cNvGrpSpPr/>
              <p:nvPr/>
            </p:nvGrpSpPr>
            <p:grpSpPr>
              <a:xfrm>
                <a:off x="1357353" y="5315938"/>
                <a:ext cx="1730155" cy="125179"/>
                <a:chOff x="1398859" y="5307310"/>
                <a:chExt cx="1730155" cy="125179"/>
              </a:xfrm>
            </p:grpSpPr>
            <p:sp>
              <p:nvSpPr>
                <p:cNvPr id="49" name="Rectangle 48"/>
                <p:cNvSpPr/>
                <p:nvPr/>
              </p:nvSpPr>
              <p:spPr>
                <a:xfrm>
                  <a:off x="3070625" y="5307310"/>
                  <a:ext cx="58389" cy="125179"/>
                </a:xfrm>
                <a:prstGeom prst="rect">
                  <a:avLst/>
                </a:prstGeom>
                <a:noFill/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0" name="Rectangle 49"/>
                <p:cNvSpPr/>
                <p:nvPr/>
              </p:nvSpPr>
              <p:spPr>
                <a:xfrm>
                  <a:off x="1398859" y="5307310"/>
                  <a:ext cx="58389" cy="125179"/>
                </a:xfrm>
                <a:prstGeom prst="rect">
                  <a:avLst/>
                </a:prstGeom>
                <a:solidFill>
                  <a:schemeClr val="accent5">
                    <a:lumMod val="50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34920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</TotalTime>
  <Words>15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Ian Armstead [ipa]</cp:lastModifiedBy>
  <cp:revision>19</cp:revision>
  <dcterms:created xsi:type="dcterms:W3CDTF">2018-08-23T09:31:54Z</dcterms:created>
  <dcterms:modified xsi:type="dcterms:W3CDTF">2018-10-22T15:53:16Z</dcterms:modified>
</cp:coreProperties>
</file>